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378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2252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4683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604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05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8974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7148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86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849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1728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8034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F9261-81FA-4EC8-BA3F-1B8079B4CE94}" type="datetimeFigureOut">
              <a:rPr lang="en-GB" smtClean="0"/>
              <a:t>1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293EA-26C8-41AE-BE7B-CCCA52A9F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3637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0" name="Table 1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3470574"/>
              </p:ext>
            </p:extLst>
          </p:nvPr>
        </p:nvGraphicFramePr>
        <p:xfrm>
          <a:off x="1402673" y="610357"/>
          <a:ext cx="5796000" cy="5527038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828000"/>
                <a:gridCol w="828000"/>
                <a:gridCol w="828000"/>
                <a:gridCol w="828000"/>
                <a:gridCol w="828000"/>
                <a:gridCol w="828000"/>
                <a:gridCol w="828000"/>
              </a:tblGrid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845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4218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071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595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0430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19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823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870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941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2032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623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305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75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988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994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141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4130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843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220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90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087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848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440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311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883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411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4235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939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302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614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103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943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450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0300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756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452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241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48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968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560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779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803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599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892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256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026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142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817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108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747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546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2291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101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849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921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3389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609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312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282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258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084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631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562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738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427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525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459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155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840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860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751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343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623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063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264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271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362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175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601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888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17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367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810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63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180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826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986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182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384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556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78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808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929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4991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190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261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817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178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838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215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5596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57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923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887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10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60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611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2820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69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99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8048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176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20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012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456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14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100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440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989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30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192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517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70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00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484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1227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53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988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604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4149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04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544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9924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149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1990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6784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4638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12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833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03043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9499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072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5271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9744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415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203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v1_2f1_1381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229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v1_2f1_41767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718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7568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004009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026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TRIRE0123202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22501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53</Words>
  <Application>Microsoft Office PowerPoint</Application>
  <PresentationFormat>On-screen Show (4:3)</PresentationFormat>
  <Paragraphs>1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T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 Wesley</dc:creator>
  <cp:lastModifiedBy>wez</cp:lastModifiedBy>
  <cp:revision>9</cp:revision>
  <dcterms:created xsi:type="dcterms:W3CDTF">2014-05-30T13:25:21Z</dcterms:created>
  <dcterms:modified xsi:type="dcterms:W3CDTF">2014-09-15T19:24:01Z</dcterms:modified>
</cp:coreProperties>
</file>